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684" y="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1/11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11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11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11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11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11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11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11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11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11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11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1/11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1/11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://creativecommons.org/licenses/by/4.0/" TargetMode="External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23528" y="5517232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Jendle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3) Diabetologia DOI 10.1007/s00125-023-06049-5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3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116632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Device and data interoperability and the way ahead</a:t>
            </a:r>
            <a:endParaRPr lang="en-GB" sz="20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8BF9E9A-A111-A5A1-7756-010F12404B2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27783" y="548680"/>
            <a:ext cx="3907217" cy="56166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51520" y="272842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The three levels of data interoperability in present diabetes management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FA9663F-A88B-C18A-4A1D-996B56A206A7}"/>
              </a:ext>
            </a:extLst>
          </p:cNvPr>
          <p:cNvSpPr txBox="1"/>
          <p:nvPr/>
        </p:nvSpPr>
        <p:spPr>
          <a:xfrm>
            <a:off x="323528" y="5520714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Jendle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3) Diabetologia DOI 10.1007/s00125-023-06049-5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3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3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9B75F67-FAA4-F1C2-994B-B3CBA96A3E8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2217" y="908720"/>
            <a:ext cx="8539565" cy="4804566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9</Words>
  <Application>Microsoft Office PowerPoint</Application>
  <PresentationFormat>On-screen Show (4:3)</PresentationFormat>
  <Paragraphs>11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5</cp:revision>
  <dcterms:created xsi:type="dcterms:W3CDTF">2016-06-15T12:53:43Z</dcterms:created>
  <dcterms:modified xsi:type="dcterms:W3CDTF">2023-11-21T13:32:25Z</dcterms:modified>
</cp:coreProperties>
</file>